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13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ur&#233;lie\Documents\Aur&#233;lie%20Chanson-Roll&#233;\Kraft\WG%20reco\part%202\New%20search_New%20MA_March%202015\nouvelle%20MA\calculs_ne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0.13299290300639882"/>
          <c:w val="0.91466332474206491"/>
          <c:h val="0.75584379782565969"/>
        </c:manualLayout>
      </c:layout>
      <c:scatterChart>
        <c:scatterStyle val="lineMarker"/>
        <c:varyColors val="0"/>
        <c:ser>
          <c:idx val="0"/>
          <c:order val="0"/>
          <c:tx>
            <c:v>Montonen 2003</c:v>
          </c:tx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figure 2 semi-log'!$C$2:$C$5</c:f>
              <c:numCache>
                <c:formatCode>General</c:formatCode>
                <c:ptCount val="4"/>
                <c:pt idx="0">
                  <c:v>1.6053050461411094</c:v>
                </c:pt>
                <c:pt idx="1">
                  <c:v>1.841359470454855</c:v>
                </c:pt>
                <c:pt idx="2">
                  <c:v>2.0043213737826426</c:v>
                </c:pt>
                <c:pt idx="3">
                  <c:v>2.1875207208364631</c:v>
                </c:pt>
              </c:numCache>
            </c:numRef>
          </c:xVal>
          <c:yVal>
            <c:numRef>
              <c:f>'figure 2 semi-log'!$D$2:$D$5</c:f>
              <c:numCache>
                <c:formatCode>General</c:formatCode>
                <c:ptCount val="4"/>
                <c:pt idx="0">
                  <c:v>5.61</c:v>
                </c:pt>
                <c:pt idx="1">
                  <c:v>4.7300000000000004</c:v>
                </c:pt>
                <c:pt idx="2">
                  <c:v>2.12</c:v>
                </c:pt>
                <c:pt idx="3">
                  <c:v>2.0299999999999998</c:v>
                </c:pt>
              </c:numCache>
            </c:numRef>
          </c:yVal>
          <c:smooth val="0"/>
        </c:ser>
        <c:ser>
          <c:idx val="1"/>
          <c:order val="1"/>
          <c:tx>
            <c:v>Sun 2010 - HPFS</c:v>
          </c:tx>
          <c:spPr>
            <a:ln w="28575">
              <a:noFill/>
            </a:ln>
          </c:spPr>
          <c:marker>
            <c:symbol val="circle"/>
            <c:size val="18"/>
            <c:spPr>
              <a:pattFill prst="ltDnDiag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marker>
          <c:xVal>
            <c:numRef>
              <c:f>'figure 2 semi-log'!$C$6:$C$10</c:f>
              <c:numCache>
                <c:formatCode>General</c:formatCode>
                <c:ptCount val="5"/>
                <c:pt idx="0">
                  <c:v>0.70757017609793638</c:v>
                </c:pt>
                <c:pt idx="1">
                  <c:v>1.1003705451175629</c:v>
                </c:pt>
                <c:pt idx="2">
                  <c:v>1.3096301674258988</c:v>
                </c:pt>
                <c:pt idx="3">
                  <c:v>1.4756711883244296</c:v>
                </c:pt>
                <c:pt idx="4">
                  <c:v>1.6730209071288962</c:v>
                </c:pt>
              </c:numCache>
            </c:numRef>
          </c:xVal>
          <c:yVal>
            <c:numRef>
              <c:f>'figure 2 semi-log'!$D$6:$D$10</c:f>
              <c:numCache>
                <c:formatCode>General</c:formatCode>
                <c:ptCount val="5"/>
                <c:pt idx="0">
                  <c:v>8.42</c:v>
                </c:pt>
                <c:pt idx="1">
                  <c:v>7.07</c:v>
                </c:pt>
                <c:pt idx="2">
                  <c:v>6.95</c:v>
                </c:pt>
                <c:pt idx="3">
                  <c:v>5.93</c:v>
                </c:pt>
                <c:pt idx="4">
                  <c:v>4.8600000000000003</c:v>
                </c:pt>
              </c:numCache>
            </c:numRef>
          </c:yVal>
          <c:smooth val="0"/>
        </c:ser>
        <c:ser>
          <c:idx val="2"/>
          <c:order val="2"/>
          <c:tx>
            <c:v>Sun 2010 - NHS I</c:v>
          </c:tx>
          <c:spPr>
            <a:ln w="28575">
              <a:noFill/>
            </a:ln>
          </c:spPr>
          <c:marker>
            <c:symbol val="circle"/>
            <c:size val="24"/>
            <c:spPr>
              <a:noFill/>
              <a:ln>
                <a:solidFill>
                  <a:schemeClr val="tx1"/>
                </a:solidFill>
                <a:prstDash val="dash"/>
              </a:ln>
            </c:spPr>
          </c:marker>
          <c:xVal>
            <c:numRef>
              <c:f>'figure 2 semi-log'!$C$11:$C$15</c:f>
              <c:numCache>
                <c:formatCode>General</c:formatCode>
                <c:ptCount val="5"/>
                <c:pt idx="0">
                  <c:v>0.55630250076728727</c:v>
                </c:pt>
                <c:pt idx="1">
                  <c:v>0.91381385238371671</c:v>
                </c:pt>
                <c:pt idx="2">
                  <c:v>1.1139433523068367</c:v>
                </c:pt>
                <c:pt idx="3">
                  <c:v>1.287801729930226</c:v>
                </c:pt>
                <c:pt idx="4">
                  <c:v>1.4955443375464486</c:v>
                </c:pt>
              </c:numCache>
            </c:numRef>
          </c:xVal>
          <c:yVal>
            <c:numRef>
              <c:f>'figure 2 semi-log'!$D$11:$D$15</c:f>
              <c:numCache>
                <c:formatCode>General</c:formatCode>
                <c:ptCount val="5"/>
                <c:pt idx="0">
                  <c:v>9.76</c:v>
                </c:pt>
                <c:pt idx="1">
                  <c:v>8.92</c:v>
                </c:pt>
                <c:pt idx="2">
                  <c:v>8.35</c:v>
                </c:pt>
                <c:pt idx="3">
                  <c:v>6.95</c:v>
                </c:pt>
                <c:pt idx="4">
                  <c:v>5.76</c:v>
                </c:pt>
              </c:numCache>
            </c:numRef>
          </c:yVal>
          <c:smooth val="0"/>
        </c:ser>
        <c:ser>
          <c:idx val="3"/>
          <c:order val="3"/>
          <c:tx>
            <c:v>Sun 2010 - NHS II</c:v>
          </c:tx>
          <c:spPr>
            <a:ln w="28575">
              <a:noFill/>
            </a:ln>
          </c:spPr>
          <c:marker>
            <c:symbol val="circle"/>
            <c:size val="27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figure 2 semi-log'!$C$16:$C$20</c:f>
              <c:numCache>
                <c:formatCode>General</c:formatCode>
                <c:ptCount val="5"/>
                <c:pt idx="0">
                  <c:v>0.79239168949825389</c:v>
                </c:pt>
                <c:pt idx="1">
                  <c:v>1.1003705451175629</c:v>
                </c:pt>
                <c:pt idx="2">
                  <c:v>1.2741578492636798</c:v>
                </c:pt>
                <c:pt idx="3">
                  <c:v>1.4183012913197455</c:v>
                </c:pt>
                <c:pt idx="4">
                  <c:v>1.6020599913279623</c:v>
                </c:pt>
              </c:numCache>
            </c:numRef>
          </c:xVal>
          <c:yVal>
            <c:numRef>
              <c:f>'figure 2 semi-log'!$D$16:$D$20</c:f>
              <c:numCache>
                <c:formatCode>General</c:formatCode>
                <c:ptCount val="5"/>
                <c:pt idx="0">
                  <c:v>3.85</c:v>
                </c:pt>
                <c:pt idx="1">
                  <c:v>2.98</c:v>
                </c:pt>
                <c:pt idx="2">
                  <c:v>2.6</c:v>
                </c:pt>
                <c:pt idx="3">
                  <c:v>2.13</c:v>
                </c:pt>
                <c:pt idx="4">
                  <c:v>1.8</c:v>
                </c:pt>
              </c:numCache>
            </c:numRef>
          </c:yVal>
          <c:smooth val="0"/>
        </c:ser>
        <c:ser>
          <c:idx val="4"/>
          <c:order val="4"/>
          <c:tx>
            <c:v>Meyer 2000</c:v>
          </c:tx>
          <c:spPr>
            <a:ln w="28575">
              <a:noFill/>
            </a:ln>
          </c:spPr>
          <c:marker>
            <c:symbol val="circle"/>
            <c:size val="17"/>
            <c:spPr>
              <a:pattFill prst="pct1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marker>
          <c:xVal>
            <c:numRef>
              <c:f>'figure 2 semi-log'!$C$21:$C$25</c:f>
              <c:numCache>
                <c:formatCode>General</c:formatCode>
                <c:ptCount val="5"/>
                <c:pt idx="0">
                  <c:v>0.34242268082220628</c:v>
                </c:pt>
                <c:pt idx="1">
                  <c:v>0.93951925261861846</c:v>
                </c:pt>
                <c:pt idx="2">
                  <c:v>1.1846914308175989</c:v>
                </c:pt>
                <c:pt idx="3">
                  <c:v>1.3617278360175928</c:v>
                </c:pt>
                <c:pt idx="4">
                  <c:v>1.651278013998144</c:v>
                </c:pt>
              </c:numCache>
            </c:numRef>
          </c:xVal>
          <c:yVal>
            <c:numRef>
              <c:f>'figure 2 semi-log'!$D$21:$D$25</c:f>
              <c:numCache>
                <c:formatCode>General</c:formatCode>
                <c:ptCount val="5"/>
                <c:pt idx="0">
                  <c:v>3.47</c:v>
                </c:pt>
                <c:pt idx="1">
                  <c:v>3.25</c:v>
                </c:pt>
                <c:pt idx="2">
                  <c:v>3.25</c:v>
                </c:pt>
                <c:pt idx="3">
                  <c:v>3</c:v>
                </c:pt>
                <c:pt idx="4">
                  <c:v>2.88</c:v>
                </c:pt>
              </c:numCache>
            </c:numRef>
          </c:yVal>
          <c:smooth val="0"/>
        </c:ser>
        <c:ser>
          <c:idx val="5"/>
          <c:order val="5"/>
          <c:tx>
            <c:v>Esmaillzadeh 2005</c:v>
          </c:tx>
          <c:spPr>
            <a:ln w="28575">
              <a:noFill/>
            </a:ln>
          </c:spPr>
          <c:marker>
            <c:symbol val="circle"/>
            <c:size val="3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marker>
          <c:xVal>
            <c:numRef>
              <c:f>'figure 2 semi-log'!$C$26:$C$29</c:f>
              <c:numCache>
                <c:formatCode>General</c:formatCode>
                <c:ptCount val="4"/>
                <c:pt idx="0">
                  <c:v>0.49136169383427269</c:v>
                </c:pt>
                <c:pt idx="1">
                  <c:v>1.3096301674258988</c:v>
                </c:pt>
                <c:pt idx="2">
                  <c:v>1.72916478969277</c:v>
                </c:pt>
                <c:pt idx="3">
                  <c:v>2.0674428427763805</c:v>
                </c:pt>
              </c:numCache>
            </c:numRef>
          </c:xVal>
          <c:yVal>
            <c:numRef>
              <c:f>'figure 2 semi-log'!$D$26:$D$29</c:f>
              <c:numCache>
                <c:formatCode>General</c:formatCode>
                <c:ptCount val="4"/>
                <c:pt idx="0">
                  <c:v>5.0599999999999996</c:v>
                </c:pt>
                <c:pt idx="1">
                  <c:v>2.84</c:v>
                </c:pt>
                <c:pt idx="2">
                  <c:v>2.93</c:v>
                </c:pt>
                <c:pt idx="3">
                  <c:v>1.91</c:v>
                </c:pt>
              </c:numCache>
            </c:numRef>
          </c:yVal>
          <c:smooth val="0"/>
        </c:ser>
        <c:ser>
          <c:idx val="6"/>
          <c:order val="6"/>
          <c:tx>
            <c:v>dummy</c:v>
          </c:tx>
          <c:spPr>
            <a:ln w="28575">
              <a:noFill/>
            </a:ln>
          </c:spPr>
          <c:marker>
            <c:symbol val="none"/>
          </c:marker>
          <c:xVal>
            <c:numRef>
              <c:f>'figure 2 semi-log'!$P$3:$P$39</c:f>
              <c:numCache>
                <c:formatCode>General</c:formatCode>
                <c:ptCount val="37"/>
                <c:pt idx="0">
                  <c:v>0.33959339086011253</c:v>
                </c:pt>
                <c:pt idx="1">
                  <c:v>0.43996393592090488</c:v>
                </c:pt>
                <c:pt idx="2">
                  <c:v>0.48572142648158001</c:v>
                </c:pt>
                <c:pt idx="3">
                  <c:v>0.55630250076728727</c:v>
                </c:pt>
                <c:pt idx="4">
                  <c:v>0.70757017609793638</c:v>
                </c:pt>
                <c:pt idx="5">
                  <c:v>0.78675142214556115</c:v>
                </c:pt>
                <c:pt idx="6">
                  <c:v>0.79239168949825389</c:v>
                </c:pt>
                <c:pt idx="7">
                  <c:v>0.91381385238371671</c:v>
                </c:pt>
                <c:pt idx="8">
                  <c:v>0.94165338213840066</c:v>
                </c:pt>
                <c:pt idx="9">
                  <c:v>1.0655050230983902</c:v>
                </c:pt>
                <c:pt idx="10">
                  <c:v>1.1003705451175629</c:v>
                </c:pt>
                <c:pt idx="11">
                  <c:v>1.1003705451175629</c:v>
                </c:pt>
                <c:pt idx="12">
                  <c:v>1.1139433523068367</c:v>
                </c:pt>
                <c:pt idx="13">
                  <c:v>1.1846914308175989</c:v>
                </c:pt>
                <c:pt idx="14">
                  <c:v>1.2741578492636798</c:v>
                </c:pt>
                <c:pt idx="15">
                  <c:v>1.2745965422569967</c:v>
                </c:pt>
                <c:pt idx="16">
                  <c:v>1.287801729930226</c:v>
                </c:pt>
                <c:pt idx="17">
                  <c:v>1.3096301674258988</c:v>
                </c:pt>
                <c:pt idx="18">
                  <c:v>1.3096301674258988</c:v>
                </c:pt>
                <c:pt idx="19">
                  <c:v>1.3159703454569178</c:v>
                </c:pt>
                <c:pt idx="20">
                  <c:v>1.36078268987328</c:v>
                </c:pt>
                <c:pt idx="21">
                  <c:v>1.4183012913197455</c:v>
                </c:pt>
                <c:pt idx="22">
                  <c:v>1.4202198777251478</c:v>
                </c:pt>
                <c:pt idx="23">
                  <c:v>1.4756711883244296</c:v>
                </c:pt>
                <c:pt idx="24">
                  <c:v>1.4955443375464486</c:v>
                </c:pt>
                <c:pt idx="25">
                  <c:v>1.5979911948988506</c:v>
                </c:pt>
                <c:pt idx="26">
                  <c:v>1.6020599913279623</c:v>
                </c:pt>
                <c:pt idx="27">
                  <c:v>1.6051972673883779</c:v>
                </c:pt>
                <c:pt idx="28">
                  <c:v>1.6364878963533653</c:v>
                </c:pt>
                <c:pt idx="29">
                  <c:v>1.6513472518867891</c:v>
                </c:pt>
                <c:pt idx="30">
                  <c:v>1.6730209071288962</c:v>
                </c:pt>
                <c:pt idx="31">
                  <c:v>1.7287594751678743</c:v>
                </c:pt>
                <c:pt idx="32">
                  <c:v>1.8411090844681539</c:v>
                </c:pt>
                <c:pt idx="33">
                  <c:v>1.8836614351536176</c:v>
                </c:pt>
                <c:pt idx="34">
                  <c:v>2.0042353663594676</c:v>
                </c:pt>
                <c:pt idx="35">
                  <c:v>2.0674056584378242</c:v>
                </c:pt>
                <c:pt idx="36">
                  <c:v>2.1875771190550872</c:v>
                </c:pt>
              </c:numCache>
            </c:numRef>
          </c:xVal>
          <c:yVal>
            <c:numRef>
              <c:f>'figure 2 semi-log'!$Q$3:$Q$39</c:f>
              <c:numCache>
                <c:formatCode>General</c:formatCode>
                <c:ptCount val="37"/>
                <c:pt idx="0">
                  <c:v>5.6039346400000003</c:v>
                </c:pt>
                <c:pt idx="1">
                  <c:v>5.5873027200000003</c:v>
                </c:pt>
                <c:pt idx="2">
                  <c:v>5.5783470699999995</c:v>
                </c:pt>
                <c:pt idx="3">
                  <c:v>5.5625429799999999</c:v>
                </c:pt>
                <c:pt idx="4">
                  <c:v>5.5186427399999998</c:v>
                </c:pt>
                <c:pt idx="5">
                  <c:v>5.4887905799999999</c:v>
                </c:pt>
                <c:pt idx="6">
                  <c:v>5.4864492299999998</c:v>
                </c:pt>
                <c:pt idx="7">
                  <c:v>5.4279155699999997</c:v>
                </c:pt>
                <c:pt idx="8">
                  <c:v>5.4120278700000002</c:v>
                </c:pt>
                <c:pt idx="9">
                  <c:v>5.3275888899999995</c:v>
                </c:pt>
                <c:pt idx="10">
                  <c:v>5.29914153</c:v>
                </c:pt>
                <c:pt idx="11">
                  <c:v>5.29914153</c:v>
                </c:pt>
                <c:pt idx="12">
                  <c:v>5.2874347999999998</c:v>
                </c:pt>
                <c:pt idx="13">
                  <c:v>5.2201210900000001</c:v>
                </c:pt>
                <c:pt idx="14">
                  <c:v>5.1176871899999998</c:v>
                </c:pt>
                <c:pt idx="15">
                  <c:v>5.1171311199999998</c:v>
                </c:pt>
                <c:pt idx="16">
                  <c:v>5.1001270999999999</c:v>
                </c:pt>
                <c:pt idx="17">
                  <c:v>5.0708602699999998</c:v>
                </c:pt>
                <c:pt idx="18">
                  <c:v>5.0708602699999998</c:v>
                </c:pt>
                <c:pt idx="19">
                  <c:v>5.0620802200000004</c:v>
                </c:pt>
                <c:pt idx="20">
                  <c:v>4.9962298600000006</c:v>
                </c:pt>
                <c:pt idx="21">
                  <c:v>4.9011126599999999</c:v>
                </c:pt>
                <c:pt idx="22">
                  <c:v>4.8977177100000002</c:v>
                </c:pt>
                <c:pt idx="23">
                  <c:v>4.7928253999999999</c:v>
                </c:pt>
                <c:pt idx="24">
                  <c:v>4.7518518400000005</c:v>
                </c:pt>
                <c:pt idx="25">
                  <c:v>4.5081469600000004</c:v>
                </c:pt>
                <c:pt idx="26">
                  <c:v>4.4972304300000001</c:v>
                </c:pt>
                <c:pt idx="27">
                  <c:v>4.4887430500000001</c:v>
                </c:pt>
                <c:pt idx="28">
                  <c:v>4.4006498999999994</c:v>
                </c:pt>
                <c:pt idx="29">
                  <c:v>4.3565406100000006</c:v>
                </c:pt>
                <c:pt idx="30">
                  <c:v>4.2894359499999997</c:v>
                </c:pt>
                <c:pt idx="31">
                  <c:v>4.1006649099999999</c:v>
                </c:pt>
                <c:pt idx="32">
                  <c:v>3.6379563599999996</c:v>
                </c:pt>
                <c:pt idx="33">
                  <c:v>3.4289912</c:v>
                </c:pt>
                <c:pt idx="34">
                  <c:v>2.7125392500000003</c:v>
                </c:pt>
                <c:pt idx="35">
                  <c:v>2.24983069</c:v>
                </c:pt>
                <c:pt idx="36">
                  <c:v>1.1602266800000001</c:v>
                </c:pt>
              </c:numCache>
            </c:numRef>
          </c:yVal>
          <c:smooth val="0"/>
        </c:ser>
        <c:ser>
          <c:idx val="7"/>
          <c:order val="7"/>
          <c:tx>
            <c:v>Parker 2013</c:v>
          </c:tx>
          <c:spPr>
            <a:ln w="28575">
              <a:noFill/>
            </a:ln>
          </c:spPr>
          <c:marker>
            <c:symbol val="circle"/>
            <c:size val="7"/>
            <c:spPr>
              <a:pattFill prst="ltHorz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  <a:prstDash val="dash"/>
              </a:ln>
            </c:spPr>
          </c:marker>
          <c:dPt>
            <c:idx val="0"/>
            <c:marker>
              <c:symbol val="circle"/>
              <c:size val="13"/>
            </c:marker>
            <c:bubble3D val="0"/>
          </c:dPt>
          <c:dPt>
            <c:idx val="1"/>
            <c:marker>
              <c:symbol val="circle"/>
              <c:size val="17"/>
            </c:marker>
            <c:bubble3D val="0"/>
          </c:dPt>
          <c:dPt>
            <c:idx val="2"/>
            <c:marker>
              <c:symbol val="circle"/>
              <c:size val="30"/>
            </c:marker>
            <c:bubble3D val="0"/>
          </c:dPt>
          <c:dPt>
            <c:idx val="3"/>
            <c:marker>
              <c:symbol val="circle"/>
              <c:size val="28"/>
            </c:marker>
            <c:bubble3D val="0"/>
          </c:dPt>
          <c:dPt>
            <c:idx val="4"/>
            <c:marker>
              <c:symbol val="circle"/>
              <c:size val="20"/>
            </c:marker>
            <c:bubble3D val="0"/>
          </c:dPt>
          <c:dPt>
            <c:idx val="5"/>
            <c:marker>
              <c:symbol val="circle"/>
              <c:size val="18"/>
            </c:marker>
            <c:bubble3D val="0"/>
          </c:dPt>
          <c:xVal>
            <c:numRef>
              <c:f>'figure 2 semi-log'!$C$30:$C$35</c:f>
              <c:numCache>
                <c:formatCode>General</c:formatCode>
                <c:ptCount val="6"/>
                <c:pt idx="0">
                  <c:v>0.43996393592090488</c:v>
                </c:pt>
                <c:pt idx="1">
                  <c:v>0.78675142214556115</c:v>
                </c:pt>
                <c:pt idx="2">
                  <c:v>1.0655050230983902</c:v>
                </c:pt>
                <c:pt idx="3">
                  <c:v>1.2745965422569967</c:v>
                </c:pt>
                <c:pt idx="4">
                  <c:v>1.4202198777251478</c:v>
                </c:pt>
                <c:pt idx="5">
                  <c:v>1.5979911948988506</c:v>
                </c:pt>
              </c:numCache>
            </c:numRef>
          </c:xVal>
          <c:yVal>
            <c:numRef>
              <c:f>'figure 2 semi-log'!$D$30:$D$35</c:f>
              <c:numCache>
                <c:formatCode>General</c:formatCode>
                <c:ptCount val="6"/>
                <c:pt idx="0">
                  <c:v>5.96</c:v>
                </c:pt>
                <c:pt idx="1">
                  <c:v>5.17</c:v>
                </c:pt>
                <c:pt idx="2">
                  <c:v>4.75</c:v>
                </c:pt>
                <c:pt idx="3">
                  <c:v>4.75</c:v>
                </c:pt>
                <c:pt idx="4">
                  <c:v>4.54</c:v>
                </c:pt>
                <c:pt idx="5">
                  <c:v>4.45</c:v>
                </c:pt>
              </c:numCache>
            </c:numRef>
          </c:yVal>
          <c:smooth val="0"/>
        </c:ser>
        <c:ser>
          <c:idx val="8"/>
          <c:order val="8"/>
          <c:tx>
            <c:v>Wirstrom 2013</c:v>
          </c:tx>
          <c:spPr>
            <a:ln w="28575">
              <a:noFill/>
            </a:ln>
          </c:spPr>
          <c:marker>
            <c:symbol val="circle"/>
            <c:size val="9"/>
            <c:spPr>
              <a:pattFill prst="dkVert">
                <a:fgClr>
                  <a:schemeClr val="tx1">
                    <a:lumMod val="50000"/>
                    <a:lumOff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marker>
          <c:xVal>
            <c:numRef>
              <c:f>'figure 2 semi-log'!$C$36:$C$38</c:f>
              <c:numCache>
                <c:formatCode>General</c:formatCode>
                <c:ptCount val="3"/>
                <c:pt idx="0">
                  <c:v>1.3159703454569178</c:v>
                </c:pt>
                <c:pt idx="1">
                  <c:v>1.6364878963533653</c:v>
                </c:pt>
                <c:pt idx="2">
                  <c:v>1.8836614351536176</c:v>
                </c:pt>
              </c:numCache>
            </c:numRef>
          </c:xVal>
          <c:yVal>
            <c:numRef>
              <c:f>'figure 2 semi-log'!$D$36:$D$38</c:f>
              <c:numCache>
                <c:formatCode>General</c:formatCode>
                <c:ptCount val="3"/>
                <c:pt idx="0">
                  <c:v>6.5</c:v>
                </c:pt>
                <c:pt idx="1">
                  <c:v>3.81</c:v>
                </c:pt>
                <c:pt idx="2">
                  <c:v>4.84</c:v>
                </c:pt>
              </c:numCache>
            </c:numRef>
          </c:yVal>
          <c:smooth val="0"/>
        </c:ser>
        <c:ser>
          <c:idx val="9"/>
          <c:order val="9"/>
          <c:tx>
            <c:v>95%CI-lower</c:v>
          </c:tx>
          <c:spPr>
            <a:ln w="6350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'figure 2 semi-log'!#REF!</c:f>
            </c:numRef>
          </c:xVal>
          <c:yVal>
            <c:numRef>
              <c:f>'figure 2 semi-log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ser>
          <c:idx val="10"/>
          <c:order val="10"/>
          <c:tx>
            <c:v>95%CI-upper</c:v>
          </c:tx>
          <c:spPr>
            <a:ln w="6350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'figure 2 semi-log'!#REF!</c:f>
            </c:numRef>
          </c:xVal>
          <c:yVal>
            <c:numRef>
              <c:f>'figure 2 semi-log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243200"/>
        <c:axId val="32800768"/>
      </c:scatterChart>
      <c:valAx>
        <c:axId val="88243200"/>
        <c:scaling>
          <c:orientation val="minMax"/>
          <c:max val="2.299999999999999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32800768"/>
        <c:crosses val="autoZero"/>
        <c:crossBetween val="midCat"/>
        <c:majorUnit val="0.25"/>
      </c:valAx>
      <c:valAx>
        <c:axId val="32800768"/>
        <c:scaling>
          <c:orientation val="minMax"/>
          <c:max val="1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8243200"/>
        <c:crosses val="autoZero"/>
        <c:crossBetween val="midCat"/>
        <c:majorUnit val="1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967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399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41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2082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6587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4569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174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849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4770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557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715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8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2"/>
          <p:cNvSpPr txBox="1">
            <a:spLocks noChangeArrowheads="1"/>
          </p:cNvSpPr>
          <p:nvPr/>
        </p:nvSpPr>
        <p:spPr bwMode="auto">
          <a:xfrm>
            <a:off x="251520" y="960848"/>
            <a:ext cx="13521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57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43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36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e </a:t>
            </a:r>
            <a:r>
              <a:rPr lang="fr-FR" altLang="fr-FR" sz="1200" dirty="0">
                <a:latin typeface="Arial" panose="020B0604020202020204" pitchFamily="34" charset="0"/>
                <a:cs typeface="Arial" panose="020B0604020202020204" pitchFamily="34" charset="0"/>
              </a:rPr>
              <a:t>of T2D in %</a:t>
            </a:r>
          </a:p>
        </p:txBody>
      </p:sp>
      <p:sp>
        <p:nvSpPr>
          <p:cNvPr id="12" name="ZoneTexte 44"/>
          <p:cNvSpPr txBox="1">
            <a:spLocks noChangeArrowheads="1"/>
          </p:cNvSpPr>
          <p:nvPr/>
        </p:nvSpPr>
        <p:spPr bwMode="auto">
          <a:xfrm>
            <a:off x="3361556" y="6352162"/>
            <a:ext cx="30219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57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43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36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163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36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g of </a:t>
            </a:r>
            <a:r>
              <a:rPr lang="fr-FR" alt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ain </a:t>
            </a:r>
            <a:r>
              <a:rPr lang="fr-FR" alt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gredient</a:t>
            </a: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fr-FR" alt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alt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/d</a:t>
            </a:r>
            <a:endParaRPr lang="fr-FR" altLang="fr-FR" sz="1200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e 22"/>
          <p:cNvGrpSpPr/>
          <p:nvPr/>
        </p:nvGrpSpPr>
        <p:grpSpPr>
          <a:xfrm>
            <a:off x="4675808" y="232660"/>
            <a:ext cx="1332856" cy="276999"/>
            <a:chOff x="4306828" y="1268394"/>
            <a:chExt cx="1332856" cy="276999"/>
          </a:xfrm>
        </p:grpSpPr>
        <p:sp>
          <p:nvSpPr>
            <p:cNvPr id="45" name="Ellipse 44"/>
            <p:cNvSpPr/>
            <p:nvPr/>
          </p:nvSpPr>
          <p:spPr>
            <a:xfrm>
              <a:off x="4306828" y="1340768"/>
              <a:ext cx="144000" cy="144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4390624" y="1268394"/>
              <a:ext cx="12490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ntonen</a:t>
              </a:r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03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e 23"/>
          <p:cNvGrpSpPr/>
          <p:nvPr/>
        </p:nvGrpSpPr>
        <p:grpSpPr>
          <a:xfrm>
            <a:off x="4667806" y="593066"/>
            <a:ext cx="1513982" cy="276999"/>
            <a:chOff x="4298826" y="1735098"/>
            <a:chExt cx="1513982" cy="276999"/>
          </a:xfrm>
        </p:grpSpPr>
        <p:sp>
          <p:nvSpPr>
            <p:cNvPr id="43" name="Ellipse 42"/>
            <p:cNvSpPr/>
            <p:nvPr/>
          </p:nvSpPr>
          <p:spPr>
            <a:xfrm>
              <a:off x="4298826" y="1795676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4390624" y="1735098"/>
              <a:ext cx="14221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n 2010 – NHS I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4672754" y="953106"/>
            <a:ext cx="1075172" cy="276999"/>
            <a:chOff x="4303774" y="2196862"/>
            <a:chExt cx="1075172" cy="276999"/>
          </a:xfrm>
        </p:grpSpPr>
        <p:sp>
          <p:nvSpPr>
            <p:cNvPr id="41" name="Ellipse 40"/>
            <p:cNvSpPr/>
            <p:nvPr/>
          </p:nvSpPr>
          <p:spPr>
            <a:xfrm>
              <a:off x="4303774" y="2254012"/>
              <a:ext cx="144000" cy="144000"/>
            </a:xfrm>
            <a:prstGeom prst="ellipse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" name="ZoneTexte 1"/>
            <p:cNvSpPr txBox="1"/>
            <p:nvPr/>
          </p:nvSpPr>
          <p:spPr>
            <a:xfrm>
              <a:off x="4384763" y="2196862"/>
              <a:ext cx="9941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yer 2000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4672754" y="1313146"/>
            <a:ext cx="1101460" cy="276999"/>
            <a:chOff x="4303774" y="2659772"/>
            <a:chExt cx="1101460" cy="276999"/>
          </a:xfrm>
        </p:grpSpPr>
        <p:sp>
          <p:nvSpPr>
            <p:cNvPr id="39" name="Ellipse 38"/>
            <p:cNvSpPr/>
            <p:nvPr/>
          </p:nvSpPr>
          <p:spPr>
            <a:xfrm>
              <a:off x="4303774" y="2720350"/>
              <a:ext cx="144000" cy="144000"/>
            </a:xfrm>
            <a:prstGeom prst="ellipse">
              <a:avLst/>
            </a:prstGeom>
            <a:pattFill prst="ltHorz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40" name="ZoneTexte 5"/>
            <p:cNvSpPr txBox="1"/>
            <p:nvPr/>
          </p:nvSpPr>
          <p:spPr>
            <a:xfrm>
              <a:off x="4385403" y="2659772"/>
              <a:ext cx="10198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ker 2013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6543352" y="238894"/>
            <a:ext cx="1481402" cy="276999"/>
            <a:chOff x="6459066" y="1274628"/>
            <a:chExt cx="1481402" cy="276999"/>
          </a:xfrm>
        </p:grpSpPr>
        <p:sp>
          <p:nvSpPr>
            <p:cNvPr id="37" name="Ellipse 36"/>
            <p:cNvSpPr/>
            <p:nvPr/>
          </p:nvSpPr>
          <p:spPr>
            <a:xfrm>
              <a:off x="6459066" y="1333148"/>
              <a:ext cx="144000" cy="144000"/>
            </a:xfrm>
            <a:prstGeom prst="ellipse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ZoneTexte 5"/>
            <p:cNvSpPr txBox="1"/>
            <p:nvPr/>
          </p:nvSpPr>
          <p:spPr>
            <a:xfrm>
              <a:off x="6551946" y="1274628"/>
              <a:ext cx="13885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n 2010 - HPFS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6531922" y="598574"/>
            <a:ext cx="1553040" cy="276999"/>
            <a:chOff x="6447636" y="1740606"/>
            <a:chExt cx="1553040" cy="276999"/>
          </a:xfrm>
        </p:grpSpPr>
        <p:sp>
          <p:nvSpPr>
            <p:cNvPr id="35" name="Ellipse 34"/>
            <p:cNvSpPr/>
            <p:nvPr/>
          </p:nvSpPr>
          <p:spPr>
            <a:xfrm>
              <a:off x="6447636" y="1795676"/>
              <a:ext cx="144000" cy="1440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6535210" y="1740606"/>
              <a:ext cx="14654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n 2010 – NHS II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e 28"/>
          <p:cNvGrpSpPr/>
          <p:nvPr/>
        </p:nvGrpSpPr>
        <p:grpSpPr>
          <a:xfrm>
            <a:off x="6602396" y="954445"/>
            <a:ext cx="1497996" cy="276999"/>
            <a:chOff x="6518110" y="2198201"/>
            <a:chExt cx="1497996" cy="276999"/>
          </a:xfrm>
        </p:grpSpPr>
        <p:sp>
          <p:nvSpPr>
            <p:cNvPr id="33" name="Ellipse 32"/>
            <p:cNvSpPr/>
            <p:nvPr/>
          </p:nvSpPr>
          <p:spPr>
            <a:xfrm>
              <a:off x="6518110" y="2316104"/>
              <a:ext cx="54000" cy="54000"/>
            </a:xfrm>
            <a:prstGeom prst="ellipse">
              <a:avLst/>
            </a:prstGeom>
            <a:pattFill prst="dkDn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ZoneTexte 5"/>
            <p:cNvSpPr txBox="1"/>
            <p:nvPr/>
          </p:nvSpPr>
          <p:spPr>
            <a:xfrm>
              <a:off x="6537816" y="2198201"/>
              <a:ext cx="1478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maillzadeh</a:t>
              </a:r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05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Groupe 29"/>
          <p:cNvGrpSpPr/>
          <p:nvPr/>
        </p:nvGrpSpPr>
        <p:grpSpPr>
          <a:xfrm>
            <a:off x="6570802" y="1313543"/>
            <a:ext cx="1239317" cy="276999"/>
            <a:chOff x="6486516" y="2660169"/>
            <a:chExt cx="1239317" cy="276999"/>
          </a:xfrm>
        </p:grpSpPr>
        <p:sp>
          <p:nvSpPr>
            <p:cNvPr id="31" name="Ellipse 30"/>
            <p:cNvSpPr/>
            <p:nvPr/>
          </p:nvSpPr>
          <p:spPr>
            <a:xfrm>
              <a:off x="6486516" y="2743210"/>
              <a:ext cx="108000" cy="108000"/>
            </a:xfrm>
            <a:prstGeom prst="ellipse">
              <a:avLst/>
            </a:prstGeom>
            <a:pattFill prst="dkVert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6542496" y="2660169"/>
              <a:ext cx="11833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irstrom</a:t>
              </a:r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13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7" name="Graphique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208519"/>
              </p:ext>
            </p:extLst>
          </p:nvPr>
        </p:nvGraphicFramePr>
        <p:xfrm>
          <a:off x="427808" y="628328"/>
          <a:ext cx="8496000" cy="59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239402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  <a:tailEnd type="arrow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8</TotalTime>
  <Words>37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élie</dc:creator>
  <cp:lastModifiedBy>Aurélie</cp:lastModifiedBy>
  <cp:revision>38</cp:revision>
  <dcterms:created xsi:type="dcterms:W3CDTF">2013-10-24T11:42:22Z</dcterms:created>
  <dcterms:modified xsi:type="dcterms:W3CDTF">2015-05-18T08:38:53Z</dcterms:modified>
</cp:coreProperties>
</file>